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8" r:id="rId19"/>
    <p:sldId id="276" r:id="rId20"/>
    <p:sldId id="277" r:id="rId21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スタイル (濃色)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56"/>
    <p:restoredTop sz="94658"/>
  </p:normalViewPr>
  <p:slideViewPr>
    <p:cSldViewPr snapToGrid="0">
      <p:cViewPr varScale="1">
        <p:scale>
          <a:sx n="120" d="100"/>
          <a:sy n="120" d="100"/>
        </p:scale>
        <p:origin x="4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00790B-F9B5-2431-645E-9B16B5E8AC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048590C-93BB-F8A4-7989-844531CB20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06E635-A3BF-1B42-D1D7-681625D87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B627BC-1470-78F1-953A-A839C0ACE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83521D-B484-A93E-DA44-FD0C5DBC5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2175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726EC9-B01F-9817-6427-5BC0A7B0A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98BBB0F-C43D-F222-28F3-C56E0BD89F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6FED84-A3AA-C163-45B3-412D10EBB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B6102C-C1C2-87D8-A7BA-06E3906ED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0CE2BA-3FD3-E59A-516A-92CE707B7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109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3FC8336-388C-A6AB-DB8B-1952916119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A7847D-5108-E136-EDC9-A12A144ED3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1AD7B6-5497-519A-81AF-80A607498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48B5FD-758F-21ED-E9EA-1500A5046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1E8844-A190-D026-8AFB-081419671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209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F9A85F-7324-DCFE-F5D9-54F098F5F8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D5FADA-3165-D9BB-0900-293BCBA848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5773D0-A456-0229-A45C-47B5695FD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FD9287-3FDC-FDAF-9E53-B5A4422A7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73A264-A13A-AFC8-E2A6-89CA8466D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142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ECB80E-8A40-67B8-6C6D-0BB5C2B15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A578703-658E-BFC7-87F7-92FA3E1FFE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D249EE-4C0B-F76F-2924-DED23F542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6D766C-908E-7C12-6FDE-FF4D9F2AE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3E886C-C675-9126-B622-CDA556421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614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83B231-F4CC-7F5A-14CD-1747B0C49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9BD40D-D764-8B43-AF77-0B25AE0F76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A58ABD3-82FB-2E26-AE98-AE5F0780B6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46A48D-BA84-5576-6091-8EB3AA636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BD7266-4270-4FA6-A95B-546ABE0B2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1899A8D-1BB3-CD9A-50C4-A5F624B45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731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1C65A1-C667-AD46-ADFA-3517E175DB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8A1CB1A-E32A-63F0-C4A3-75EEFD70A9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EB482B-CD46-4B56-1AFC-46C2033BDF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1479A91-BB2D-3FCE-21D0-399E82C7B1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E7C2D56-0F51-92AB-CC3D-4557E3E54E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D62570D-57AD-1D0D-3543-150CB9154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515C332-2C69-AF43-E819-349D383AA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0474634-1F59-31C5-A0D5-FD64E5F12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548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D6A92D-48BC-8E4B-0083-1CD60DA9B3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5484100-C248-8D2C-AE7E-460932B36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3CA625-7BEA-1E9D-3304-72E8DABEA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794CB55-1049-668B-AFA1-300B3A136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326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398F5DE-F91C-6B8C-00A9-ECA87BF6E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477B631-09AC-4F16-B158-5748AD6E8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6C3D423-F521-FF0E-D86F-01DE202B0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9596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42B5AA-13C3-4FE0-BEE9-03E8163736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2C3FB33-955F-C1F6-4E39-A23161703E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E15B135-4A41-7F7E-3667-A859AA7BE3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86E2DE4-22BC-0C82-158D-AAF4F23DD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93A9A3C-A2DC-CB04-C2B1-24BDCA93D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58027BD-DF84-542F-A5CA-65933F697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1815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A3C0B2-5FB1-784E-AD12-ADA6FE9D9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EB67018-DDFB-4A6E-6230-B4452E4D90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BED0BD6-498F-38B2-CBAF-FC843809EB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2AC3A6-7741-0AC0-8B6A-E36941E4A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E1D56EB-7089-1922-01CE-209C7AE81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2247CE2-E981-1DF1-1C1B-8562A79CF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465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21700B7-D36C-8720-CC6D-E5A65AC13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C4D9592-B386-E203-3D34-0AF0F62524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A4CC74-0DAE-DF54-3240-F9F845C277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9BA1F9-D1F1-EF4B-B02A-85B27CF309C8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CDBE53-355E-6158-B378-07722E1D3F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F412E1-12DF-8D36-081B-ECE9D12AF0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3CCF384-4DAA-DA42-BF79-285524ECCE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0810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EC7034A-3D51-BFF1-D7CE-996B8588CB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87578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CE9B08F-58CB-9F83-327B-31A65CB16B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70911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06EBA27-7887-1967-0F19-CCA44EB657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222592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311593E-3982-A188-FDAD-204A66C8B7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00140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CBAAE45-CA17-900A-53DF-A64F8D062FF8}"/>
              </a:ext>
            </a:extLst>
          </p:cNvPr>
          <p:cNvSpPr txBox="1"/>
          <p:nvPr/>
        </p:nvSpPr>
        <p:spPr>
          <a:xfrm>
            <a:off x="273268" y="578069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del1</a:t>
            </a:r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DC14150-6CB7-EC94-FB8C-0EC805D583DF}"/>
              </a:ext>
            </a:extLst>
          </p:cNvPr>
          <p:cNvSpPr txBox="1"/>
          <p:nvPr/>
        </p:nvSpPr>
        <p:spPr>
          <a:xfrm>
            <a:off x="273268" y="208737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TypeⅢ</a:t>
            </a:r>
            <a:r>
              <a:rPr kumimoji="1" lang="en-US" altLang="ja-JP" dirty="0"/>
              <a:t> test</a:t>
            </a:r>
            <a:endParaRPr kumimoji="1" lang="ja-JP" altLang="en-US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AA08738-4F1A-7845-3CF5-4D79079F9A3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5254" r="25389" b="35805"/>
          <a:stretch/>
        </p:blipFill>
        <p:spPr>
          <a:xfrm>
            <a:off x="273268" y="947401"/>
            <a:ext cx="3836277" cy="3220251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90E12C4-EC45-EB0D-8B67-D2A730A29E16}"/>
              </a:ext>
            </a:extLst>
          </p:cNvPr>
          <p:cNvSpPr txBox="1"/>
          <p:nvPr/>
        </p:nvSpPr>
        <p:spPr>
          <a:xfrm>
            <a:off x="4436982" y="4577445"/>
            <a:ext cx="11608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: p &lt; 0.05</a:t>
            </a:r>
          </a:p>
          <a:p>
            <a:r>
              <a:rPr kumimoji="1" lang="en-US" altLang="ja-JP" sz="1200" dirty="0"/>
              <a:t>**: p &lt; 0.01</a:t>
            </a:r>
            <a:endParaRPr kumimoji="1" lang="ja-JP" altLang="en-US" sz="1200"/>
          </a:p>
          <a:p>
            <a:r>
              <a:rPr kumimoji="1" lang="en-US" altLang="ja-JP" sz="1200" dirty="0"/>
              <a:t>***: p &lt; 0.001</a:t>
            </a:r>
            <a:endParaRPr kumimoji="1" lang="ja-JP" altLang="en-US" sz="1200"/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5315B00-2028-CE02-BC44-D8970FFDFB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9597011"/>
              </p:ext>
            </p:extLst>
          </p:nvPr>
        </p:nvGraphicFramePr>
        <p:xfrm>
          <a:off x="4436982" y="970645"/>
          <a:ext cx="5924186" cy="3606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76705">
                  <a:extLst>
                    <a:ext uri="{9D8B030D-6E8A-4147-A177-3AD203B41FA5}">
                      <a16:colId xmlns:a16="http://schemas.microsoft.com/office/drawing/2014/main" val="923115774"/>
                    </a:ext>
                  </a:extLst>
                </a:gridCol>
                <a:gridCol w="1613955">
                  <a:extLst>
                    <a:ext uri="{9D8B030D-6E8A-4147-A177-3AD203B41FA5}">
                      <a16:colId xmlns:a16="http://schemas.microsoft.com/office/drawing/2014/main" val="3361602515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1480112267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24653960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Variabl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um of Squares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df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F Valu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99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tercept)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1.1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58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93684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x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586.7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2.96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9411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778.9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.2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061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Month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79.2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3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252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rit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907.6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7.84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269672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lienc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350.0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1.98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9380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telligence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545.7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0.46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0412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duals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97100.92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9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228005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0619858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560FF3-6588-3AC7-E2D6-7A0FA9914CD2}"/>
              </a:ext>
            </a:extLst>
          </p:cNvPr>
          <p:cNvSpPr txBox="1"/>
          <p:nvPr/>
        </p:nvSpPr>
        <p:spPr>
          <a:xfrm>
            <a:off x="273268" y="578069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del2</a:t>
            </a:r>
            <a:endParaRPr kumimoji="1" lang="ja-JP" altLang="en-US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F289897A-9C07-0D4D-13BE-918BD1E75AD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5254" r="24712" b="35805"/>
          <a:stretch/>
        </p:blipFill>
        <p:spPr>
          <a:xfrm>
            <a:off x="160004" y="920825"/>
            <a:ext cx="3888828" cy="322025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BB4A03B-721C-58E0-08EA-FECACC1FAA51}"/>
              </a:ext>
            </a:extLst>
          </p:cNvPr>
          <p:cNvSpPr txBox="1"/>
          <p:nvPr/>
        </p:nvSpPr>
        <p:spPr>
          <a:xfrm>
            <a:off x="4576832" y="4511916"/>
            <a:ext cx="11608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: p &lt; 0.05</a:t>
            </a:r>
          </a:p>
          <a:p>
            <a:r>
              <a:rPr kumimoji="1" lang="en-US" altLang="ja-JP" sz="1200" dirty="0"/>
              <a:t>**: p &lt; 0.01</a:t>
            </a:r>
            <a:endParaRPr kumimoji="1" lang="ja-JP" altLang="en-US" sz="1200"/>
          </a:p>
          <a:p>
            <a:r>
              <a:rPr kumimoji="1" lang="en-US" altLang="ja-JP" sz="1200" dirty="0"/>
              <a:t>***: p &lt; 0.001</a:t>
            </a:r>
            <a:endParaRPr kumimoji="1" lang="ja-JP" altLang="en-US" sz="120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7B981577-3C7D-6ECA-6D5D-053E3466CE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9275575"/>
              </p:ext>
            </p:extLst>
          </p:nvPr>
        </p:nvGraphicFramePr>
        <p:xfrm>
          <a:off x="4576832" y="905116"/>
          <a:ext cx="5924186" cy="3606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51846">
                  <a:extLst>
                    <a:ext uri="{9D8B030D-6E8A-4147-A177-3AD203B41FA5}">
                      <a16:colId xmlns:a16="http://schemas.microsoft.com/office/drawing/2014/main" val="923115774"/>
                    </a:ext>
                  </a:extLst>
                </a:gridCol>
                <a:gridCol w="1538814">
                  <a:extLst>
                    <a:ext uri="{9D8B030D-6E8A-4147-A177-3AD203B41FA5}">
                      <a16:colId xmlns:a16="http://schemas.microsoft.com/office/drawing/2014/main" val="3361602515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1480112267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24653960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Variabl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um of Squares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df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F Valu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99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tercept)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754.8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8.04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93684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x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039.2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.93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9411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25.0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0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061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Month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.3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0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252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ower Grade</a:t>
                      </a:r>
                      <a:r>
                        <a:rPr lang="ja-JP" altLang="ja-JP">
                          <a:effectLst/>
                        </a:rPr>
                        <a:t> 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017.78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1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269672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iddle Grade</a:t>
                      </a:r>
                      <a:r>
                        <a:rPr lang="ja-JP" altLang="ja-JP">
                          <a:effectLst/>
                        </a:rPr>
                        <a:t> 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851.25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.41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9380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igher Grad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124.85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.87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0412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duals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85103.3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9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62605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8743424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A44C52F-D2D0-5BBF-0932-903901229356}"/>
              </a:ext>
            </a:extLst>
          </p:cNvPr>
          <p:cNvSpPr txBox="1"/>
          <p:nvPr/>
        </p:nvSpPr>
        <p:spPr>
          <a:xfrm>
            <a:off x="273268" y="578069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del3</a:t>
            </a:r>
            <a:endParaRPr kumimoji="1" lang="ja-JP" altLang="en-US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8C267B8-B018-DB71-E48C-B3C127EF4E3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5388" r="24713" b="50000"/>
          <a:stretch/>
        </p:blipFill>
        <p:spPr>
          <a:xfrm>
            <a:off x="273268" y="920825"/>
            <a:ext cx="3878318" cy="250817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9BB50FA-0850-6F00-D314-0EEB93AD5DDD}"/>
              </a:ext>
            </a:extLst>
          </p:cNvPr>
          <p:cNvSpPr txBox="1"/>
          <p:nvPr/>
        </p:nvSpPr>
        <p:spPr>
          <a:xfrm>
            <a:off x="4707852" y="3882744"/>
            <a:ext cx="11608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: p &lt; 0.05</a:t>
            </a:r>
          </a:p>
          <a:p>
            <a:r>
              <a:rPr kumimoji="1" lang="en-US" altLang="ja-JP" sz="1200" dirty="0"/>
              <a:t>**: p &lt; 0.01</a:t>
            </a:r>
            <a:endParaRPr kumimoji="1" lang="ja-JP" altLang="en-US" sz="1200"/>
          </a:p>
          <a:p>
            <a:r>
              <a:rPr kumimoji="1" lang="en-US" altLang="ja-JP" sz="1200" dirty="0"/>
              <a:t>***: p &lt; 0.001</a:t>
            </a:r>
            <a:endParaRPr kumimoji="1" lang="ja-JP" altLang="en-US" sz="120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86C17261-8FB4-3D21-3B4D-94F843DF56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4658180"/>
              </p:ext>
            </p:extLst>
          </p:nvPr>
        </p:nvGraphicFramePr>
        <p:xfrm>
          <a:off x="4791984" y="947401"/>
          <a:ext cx="5924186" cy="28651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51846">
                  <a:extLst>
                    <a:ext uri="{9D8B030D-6E8A-4147-A177-3AD203B41FA5}">
                      <a16:colId xmlns:a16="http://schemas.microsoft.com/office/drawing/2014/main" val="923115774"/>
                    </a:ext>
                  </a:extLst>
                </a:gridCol>
                <a:gridCol w="1538814">
                  <a:extLst>
                    <a:ext uri="{9D8B030D-6E8A-4147-A177-3AD203B41FA5}">
                      <a16:colId xmlns:a16="http://schemas.microsoft.com/office/drawing/2014/main" val="3361602515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1480112267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24653960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Variabl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um of Squares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df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F Valu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99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tercept)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19.1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8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93684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x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440.7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3.80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9411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767.65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8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061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Month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5.6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1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252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order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193.2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70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0412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duals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07992.75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9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848399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4743269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86C7143-2650-AB44-BFB7-EB93FF9DCD85}"/>
              </a:ext>
            </a:extLst>
          </p:cNvPr>
          <p:cNvSpPr txBox="1"/>
          <p:nvPr/>
        </p:nvSpPr>
        <p:spPr>
          <a:xfrm>
            <a:off x="273268" y="578069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del4</a:t>
            </a:r>
            <a:endParaRPr kumimoji="1"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A49DB67-8AA9-BDD3-BE6A-1989E34175E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5254" r="24577" b="50000"/>
          <a:stretch/>
        </p:blipFill>
        <p:spPr>
          <a:xfrm>
            <a:off x="273267" y="947401"/>
            <a:ext cx="3899339" cy="250817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3742460-9D2A-0DFA-D398-AD2BC8F91E26}"/>
              </a:ext>
            </a:extLst>
          </p:cNvPr>
          <p:cNvSpPr txBox="1"/>
          <p:nvPr/>
        </p:nvSpPr>
        <p:spPr>
          <a:xfrm>
            <a:off x="4791984" y="3812521"/>
            <a:ext cx="11608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: p &lt; 0.05</a:t>
            </a:r>
          </a:p>
          <a:p>
            <a:r>
              <a:rPr kumimoji="1" lang="en-US" altLang="ja-JP" sz="1200" dirty="0"/>
              <a:t>**: p &lt; 0.01</a:t>
            </a:r>
            <a:endParaRPr kumimoji="1" lang="ja-JP" altLang="en-US" sz="1200"/>
          </a:p>
          <a:p>
            <a:r>
              <a:rPr kumimoji="1" lang="en-US" altLang="ja-JP" sz="1200" dirty="0"/>
              <a:t>***: p &lt; 0.001</a:t>
            </a:r>
            <a:endParaRPr kumimoji="1" lang="ja-JP" altLang="en-US" sz="120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D03A4F5C-73CF-DB2E-6C25-BDA4A1B8D2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9582341"/>
              </p:ext>
            </p:extLst>
          </p:nvPr>
        </p:nvGraphicFramePr>
        <p:xfrm>
          <a:off x="4791984" y="947401"/>
          <a:ext cx="5924186" cy="28651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51846">
                  <a:extLst>
                    <a:ext uri="{9D8B030D-6E8A-4147-A177-3AD203B41FA5}">
                      <a16:colId xmlns:a16="http://schemas.microsoft.com/office/drawing/2014/main" val="923115774"/>
                    </a:ext>
                  </a:extLst>
                </a:gridCol>
                <a:gridCol w="1538814">
                  <a:extLst>
                    <a:ext uri="{9D8B030D-6E8A-4147-A177-3AD203B41FA5}">
                      <a16:colId xmlns:a16="http://schemas.microsoft.com/office/drawing/2014/main" val="3361602515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1480112267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24653960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Variabl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um of Squares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df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F Valu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99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tercept)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08.5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82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93684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x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017.0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9.79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9411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35.9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72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061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Month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3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0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252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port History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8505.6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3.54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0412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duals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01680.3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0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627208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2783417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A17D0CC-D04F-C1DA-3732-1128EF9C5EAC}"/>
              </a:ext>
            </a:extLst>
          </p:cNvPr>
          <p:cNvSpPr txBox="1"/>
          <p:nvPr/>
        </p:nvSpPr>
        <p:spPr>
          <a:xfrm>
            <a:off x="273268" y="578069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del5</a:t>
            </a:r>
            <a:endParaRPr kumimoji="1"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33CBEDF-35B4-32DE-3CB8-EB96E79B10B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3631" r="23495" b="36015"/>
          <a:stretch/>
        </p:blipFill>
        <p:spPr>
          <a:xfrm>
            <a:off x="173730" y="947401"/>
            <a:ext cx="4109546" cy="320974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C97899-6B9E-9F9B-E248-76431A429672}"/>
              </a:ext>
            </a:extLst>
          </p:cNvPr>
          <p:cNvSpPr txBox="1"/>
          <p:nvPr/>
        </p:nvSpPr>
        <p:spPr>
          <a:xfrm>
            <a:off x="4764058" y="4747839"/>
            <a:ext cx="11608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: p &lt; 0.05</a:t>
            </a:r>
          </a:p>
          <a:p>
            <a:r>
              <a:rPr kumimoji="1" lang="en-US" altLang="ja-JP" sz="1200" dirty="0"/>
              <a:t>**: p &lt; 0.01</a:t>
            </a:r>
            <a:endParaRPr kumimoji="1" lang="ja-JP" altLang="en-US" sz="1200"/>
          </a:p>
          <a:p>
            <a:r>
              <a:rPr kumimoji="1" lang="en-US" altLang="ja-JP" sz="1200" dirty="0"/>
              <a:t>***: p &lt; 0.001</a:t>
            </a:r>
            <a:endParaRPr kumimoji="1" lang="ja-JP" altLang="en-US" sz="120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6FDF796D-2D78-26D2-D747-2FEF64C656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617953"/>
              </p:ext>
            </p:extLst>
          </p:nvPr>
        </p:nvGraphicFramePr>
        <p:xfrm>
          <a:off x="4764058" y="1141039"/>
          <a:ext cx="5924186" cy="3606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51846">
                  <a:extLst>
                    <a:ext uri="{9D8B030D-6E8A-4147-A177-3AD203B41FA5}">
                      <a16:colId xmlns:a16="http://schemas.microsoft.com/office/drawing/2014/main" val="923115774"/>
                    </a:ext>
                  </a:extLst>
                </a:gridCol>
                <a:gridCol w="1538814">
                  <a:extLst>
                    <a:ext uri="{9D8B030D-6E8A-4147-A177-3AD203B41FA5}">
                      <a16:colId xmlns:a16="http://schemas.microsoft.com/office/drawing/2014/main" val="3361602515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1480112267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24653960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Variabl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um of Squares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df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F Valu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99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tercept)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59.2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7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93684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x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029.3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.80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9411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52.9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5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061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Month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3.9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1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252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port Kind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042.9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8.91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0412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rst Sport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21.9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9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680767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" altLang="ja-JP" dirty="0">
                          <a:effectLst/>
                        </a:rPr>
                        <a:t>Competition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8991.5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.02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79699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duals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76977.3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6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912820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48740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D04815A-1985-F36D-1BAB-CF710AF06000}"/>
              </a:ext>
            </a:extLst>
          </p:cNvPr>
          <p:cNvSpPr txBox="1"/>
          <p:nvPr/>
        </p:nvSpPr>
        <p:spPr>
          <a:xfrm>
            <a:off x="273268" y="578069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del6</a:t>
            </a:r>
            <a:endParaRPr kumimoji="1" lang="ja-JP" altLang="en-US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AA5FA896-B5DB-CBC5-154F-C58A8759857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5794" r="24713" b="50000"/>
          <a:stretch/>
        </p:blipFill>
        <p:spPr>
          <a:xfrm>
            <a:off x="294289" y="947401"/>
            <a:ext cx="3846786" cy="250817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2D06D69-3724-03F7-2AA0-19C02BCE68F5}"/>
              </a:ext>
            </a:extLst>
          </p:cNvPr>
          <p:cNvSpPr txBox="1"/>
          <p:nvPr/>
        </p:nvSpPr>
        <p:spPr>
          <a:xfrm>
            <a:off x="4644146" y="3789063"/>
            <a:ext cx="11608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: p &lt; 0.05</a:t>
            </a:r>
          </a:p>
          <a:p>
            <a:r>
              <a:rPr kumimoji="1" lang="en-US" altLang="ja-JP" sz="1200" dirty="0"/>
              <a:t>**: p &lt; 0.01</a:t>
            </a:r>
            <a:endParaRPr kumimoji="1" lang="ja-JP" altLang="en-US" sz="1200"/>
          </a:p>
          <a:p>
            <a:r>
              <a:rPr kumimoji="1" lang="en-US" altLang="ja-JP" sz="1200" dirty="0"/>
              <a:t>***: p &lt; 0.001</a:t>
            </a:r>
            <a:endParaRPr kumimoji="1" lang="ja-JP" altLang="en-US" sz="120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88B8EF1D-66E0-D2DE-27DC-360B75BE8D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888741"/>
              </p:ext>
            </p:extLst>
          </p:nvPr>
        </p:nvGraphicFramePr>
        <p:xfrm>
          <a:off x="4731786" y="934720"/>
          <a:ext cx="5924186" cy="28651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51846">
                  <a:extLst>
                    <a:ext uri="{9D8B030D-6E8A-4147-A177-3AD203B41FA5}">
                      <a16:colId xmlns:a16="http://schemas.microsoft.com/office/drawing/2014/main" val="923115774"/>
                    </a:ext>
                  </a:extLst>
                </a:gridCol>
                <a:gridCol w="1538814">
                  <a:extLst>
                    <a:ext uri="{9D8B030D-6E8A-4147-A177-3AD203B41FA5}">
                      <a16:colId xmlns:a16="http://schemas.microsoft.com/office/drawing/2014/main" val="3361602515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1480112267"/>
                    </a:ext>
                  </a:extLst>
                </a:gridCol>
                <a:gridCol w="1366763">
                  <a:extLst>
                    <a:ext uri="{9D8B030D-6E8A-4147-A177-3AD203B41FA5}">
                      <a16:colId xmlns:a16="http://schemas.microsoft.com/office/drawing/2014/main" val="24653960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Variabl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um of Squares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df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F Valu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99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tercept)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74.1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6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93684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x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239.4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1.75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9411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740.3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6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061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Month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073.85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.9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252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ja-JP" dirty="0">
                          <a:effectLst/>
                        </a:rPr>
                        <a:t>Income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847.2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0.33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79699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duals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9974.1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45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630176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3145328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5A8A7AD-F14C-74DF-1191-630F83EF709F}"/>
              </a:ext>
            </a:extLst>
          </p:cNvPr>
          <p:cNvSpPr txBox="1"/>
          <p:nvPr/>
        </p:nvSpPr>
        <p:spPr>
          <a:xfrm>
            <a:off x="273268" y="578069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del7</a:t>
            </a:r>
            <a:endParaRPr kumimoji="1" lang="ja-JP" altLang="en-US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2C0A8C0-7E38-971D-5A02-3E789DF6E55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5659" r="25389" b="43138"/>
          <a:stretch/>
        </p:blipFill>
        <p:spPr>
          <a:xfrm>
            <a:off x="191536" y="947401"/>
            <a:ext cx="3804745" cy="2852389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3C29A44-021C-0213-B346-C3D58453D995}"/>
              </a:ext>
            </a:extLst>
          </p:cNvPr>
          <p:cNvSpPr txBox="1"/>
          <p:nvPr/>
        </p:nvSpPr>
        <p:spPr>
          <a:xfrm>
            <a:off x="4699512" y="4138845"/>
            <a:ext cx="11608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: p &lt; 0.05</a:t>
            </a:r>
          </a:p>
          <a:p>
            <a:r>
              <a:rPr kumimoji="1" lang="en-US" altLang="ja-JP" sz="1200" dirty="0"/>
              <a:t>**: p &lt; 0.01</a:t>
            </a:r>
            <a:endParaRPr kumimoji="1" lang="ja-JP" altLang="en-US" sz="1200"/>
          </a:p>
          <a:p>
            <a:r>
              <a:rPr kumimoji="1" lang="en-US" altLang="ja-JP" sz="1200" dirty="0"/>
              <a:t>***: p &lt; 0.001</a:t>
            </a:r>
            <a:endParaRPr kumimoji="1" lang="ja-JP" altLang="en-US" sz="120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1E8D8641-A113-80FB-CCF7-7B23DB9317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4481404"/>
              </p:ext>
            </p:extLst>
          </p:nvPr>
        </p:nvGraphicFramePr>
        <p:xfrm>
          <a:off x="4699512" y="902885"/>
          <a:ext cx="6391620" cy="32359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82181">
                  <a:extLst>
                    <a:ext uri="{9D8B030D-6E8A-4147-A177-3AD203B41FA5}">
                      <a16:colId xmlns:a16="http://schemas.microsoft.com/office/drawing/2014/main" val="923115774"/>
                    </a:ext>
                  </a:extLst>
                </a:gridCol>
                <a:gridCol w="1660231">
                  <a:extLst>
                    <a:ext uri="{9D8B030D-6E8A-4147-A177-3AD203B41FA5}">
                      <a16:colId xmlns:a16="http://schemas.microsoft.com/office/drawing/2014/main" val="3361602515"/>
                    </a:ext>
                  </a:extLst>
                </a:gridCol>
                <a:gridCol w="1474604">
                  <a:extLst>
                    <a:ext uri="{9D8B030D-6E8A-4147-A177-3AD203B41FA5}">
                      <a16:colId xmlns:a16="http://schemas.microsoft.com/office/drawing/2014/main" val="1480112267"/>
                    </a:ext>
                  </a:extLst>
                </a:gridCol>
                <a:gridCol w="1474604">
                  <a:extLst>
                    <a:ext uri="{9D8B030D-6E8A-4147-A177-3AD203B41FA5}">
                      <a16:colId xmlns:a16="http://schemas.microsoft.com/office/drawing/2014/main" val="24653960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Variabl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um of Squares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df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F Valu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99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tercept)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5.7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0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93684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x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8844.8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6.53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9411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853.7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.5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061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Month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3.3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18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252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ja-JP" dirty="0">
                          <a:effectLst/>
                        </a:rPr>
                        <a:t>Father Ability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528.1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8.70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79699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other Ability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047.6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0.85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82978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duals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89345.12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6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362043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83594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63B759A-1C7A-685A-0350-1A293CD321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943490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69CAAC2-36A2-4A15-2BED-C9260FCC2145}"/>
              </a:ext>
            </a:extLst>
          </p:cNvPr>
          <p:cNvSpPr txBox="1"/>
          <p:nvPr/>
        </p:nvSpPr>
        <p:spPr>
          <a:xfrm>
            <a:off x="273268" y="578069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Model8</a:t>
            </a:r>
            <a:endParaRPr kumimoji="1" lang="ja-JP" altLang="en-US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B9F8BE94-5F0C-422A-7E20-CFDB57D56E4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5118" r="24848" b="35805"/>
          <a:stretch/>
        </p:blipFill>
        <p:spPr>
          <a:xfrm>
            <a:off x="181766" y="1049917"/>
            <a:ext cx="3888827" cy="322025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9BBFF7B-2A7B-474D-A91E-0338D69C0973}"/>
              </a:ext>
            </a:extLst>
          </p:cNvPr>
          <p:cNvSpPr txBox="1"/>
          <p:nvPr/>
        </p:nvSpPr>
        <p:spPr>
          <a:xfrm>
            <a:off x="4656481" y="4757111"/>
            <a:ext cx="11608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: p &lt; 0.05</a:t>
            </a:r>
          </a:p>
          <a:p>
            <a:r>
              <a:rPr kumimoji="1" lang="en-US" altLang="ja-JP" sz="1200" dirty="0"/>
              <a:t>**: p &lt; 0.01</a:t>
            </a:r>
            <a:endParaRPr kumimoji="1" lang="ja-JP" altLang="en-US" sz="1200"/>
          </a:p>
          <a:p>
            <a:r>
              <a:rPr kumimoji="1" lang="en-US" altLang="ja-JP" sz="1200" dirty="0"/>
              <a:t>***: p &lt; 0.001</a:t>
            </a:r>
            <a:endParaRPr kumimoji="1" lang="ja-JP" altLang="en-US" sz="120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DEA7C720-F3FE-68BE-10E3-829A0FCB96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3199780"/>
              </p:ext>
            </p:extLst>
          </p:nvPr>
        </p:nvGraphicFramePr>
        <p:xfrm>
          <a:off x="4656481" y="1150311"/>
          <a:ext cx="7270407" cy="3606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660968">
                  <a:extLst>
                    <a:ext uri="{9D8B030D-6E8A-4147-A177-3AD203B41FA5}">
                      <a16:colId xmlns:a16="http://schemas.microsoft.com/office/drawing/2014/main" val="923115774"/>
                    </a:ext>
                  </a:extLst>
                </a:gridCol>
                <a:gridCol w="1660231">
                  <a:extLst>
                    <a:ext uri="{9D8B030D-6E8A-4147-A177-3AD203B41FA5}">
                      <a16:colId xmlns:a16="http://schemas.microsoft.com/office/drawing/2014/main" val="3361602515"/>
                    </a:ext>
                  </a:extLst>
                </a:gridCol>
                <a:gridCol w="1474604">
                  <a:extLst>
                    <a:ext uri="{9D8B030D-6E8A-4147-A177-3AD203B41FA5}">
                      <a16:colId xmlns:a16="http://schemas.microsoft.com/office/drawing/2014/main" val="1480112267"/>
                    </a:ext>
                  </a:extLst>
                </a:gridCol>
                <a:gridCol w="1474604">
                  <a:extLst>
                    <a:ext uri="{9D8B030D-6E8A-4147-A177-3AD203B41FA5}">
                      <a16:colId xmlns:a16="http://schemas.microsoft.com/office/drawing/2014/main" val="24653960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Variabl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Sum of Squares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 </a:t>
                      </a:r>
                      <a:r>
                        <a:rPr kumimoji="1" lang="en-US" altLang="ja-JP" dirty="0" err="1"/>
                        <a:t>df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F Value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999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tercept)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7.09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4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93684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x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336.4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9.98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9411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90.8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0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90611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rth Month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29.67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9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252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cognition Age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2.62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36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783247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mpliment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8976.25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3.73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79699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otor Learning Speed</a:t>
                      </a:r>
                      <a:r>
                        <a:rPr lang="ja-JP" altLang="ja-JP">
                          <a:effectLst/>
                        </a:rPr>
                        <a:t> 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688.50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6.37***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82978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iduals</a:t>
                      </a:r>
                      <a:endParaRPr kumimoji="1" lang="ja-JP" altLang="ja-JP" sz="1800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56993.1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94</a:t>
                      </a:r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61050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465513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BB5FB16-6ADC-51D3-F2EE-4219E7C84E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4333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1699A27-9F1C-056A-46DC-E9A23146E4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10131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EAFB6982-AB13-A8EF-B921-6BB3F29DC9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72352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1DF44E8-C1FC-6E89-D1A4-729C4273FF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23996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BC07537-CFA8-91AA-D0DF-FDA2D72102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9720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6F7C892-4BB3-3CF1-57B8-F24F137455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28632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6C64C268-5060-5A25-9336-14B7366760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740"/>
            <a:ext cx="7772400" cy="670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5531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447</Words>
  <Application>Microsoft Macintosh PowerPoint</Application>
  <PresentationFormat>ワイド画面</PresentationFormat>
  <Paragraphs>285</Paragraphs>
  <Slides>20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0</vt:i4>
      </vt:variant>
    </vt:vector>
  </HeadingPairs>
  <TitlesOfParts>
    <vt:vector size="24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曽我　啓史</dc:creator>
  <cp:lastModifiedBy>曽我　啓史</cp:lastModifiedBy>
  <cp:revision>5</cp:revision>
  <dcterms:created xsi:type="dcterms:W3CDTF">2024-12-01T08:18:34Z</dcterms:created>
  <dcterms:modified xsi:type="dcterms:W3CDTF">2024-12-11T09:11:12Z</dcterms:modified>
</cp:coreProperties>
</file>